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57" r:id="rId3"/>
    <p:sldId id="258" r:id="rId4"/>
    <p:sldId id="259" r:id="rId5"/>
    <p:sldId id="260" r:id="rId6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5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921"/>
  </p:normalViewPr>
  <p:slideViewPr>
    <p:cSldViewPr snapToGrid="0" showGuides="1">
      <p:cViewPr varScale="1">
        <p:scale>
          <a:sx n="73" d="100"/>
          <a:sy n="73" d="100"/>
        </p:scale>
        <p:origin x="3120" y="200"/>
      </p:cViewPr>
      <p:guideLst>
        <p:guide orient="horz" pos="345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82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58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470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738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857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814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514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904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623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379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005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81226-3B34-FD4B-99DF-A875292B5944}" type="datetimeFigureOut">
              <a:rPr lang="en-US" smtClean="0"/>
              <a:t>11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CD3A4-CAD3-EA4C-91AD-07D80010F2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74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CAADD21-F11A-2718-D963-B651700376F4}"/>
              </a:ext>
            </a:extLst>
          </p:cNvPr>
          <p:cNvSpPr txBox="1"/>
          <p:nvPr/>
        </p:nvSpPr>
        <p:spPr>
          <a:xfrm>
            <a:off x="405143" y="387850"/>
            <a:ext cx="3523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</a:t>
            </a:r>
          </a:p>
          <a:p>
            <a:endParaRPr lang="en-US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1243BD4-2A90-FC83-2BC9-E2B02A5821E7}"/>
              </a:ext>
            </a:extLst>
          </p:cNvPr>
          <p:cNvSpPr txBox="1"/>
          <p:nvPr/>
        </p:nvSpPr>
        <p:spPr>
          <a:xfrm>
            <a:off x="553334" y="9779177"/>
            <a:ext cx="621964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Functional Enrichment general pipelin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rey box indicates Semantic Classes (SCs) removed from the analysis, as they are classified as ‘general’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3AF3493C-07A5-AAC0-5147-09B71E626A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785938"/>
            <a:ext cx="7559675" cy="7118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575918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008F5A90-6408-F43A-C450-CDB15E7E22F4}"/>
              </a:ext>
            </a:extLst>
          </p:cNvPr>
          <p:cNvSpPr/>
          <p:nvPr/>
        </p:nvSpPr>
        <p:spPr>
          <a:xfrm>
            <a:off x="1920240" y="3474720"/>
            <a:ext cx="101600" cy="193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B61B3F1-FA82-CC68-5FFE-96742A8BFCBA}"/>
              </a:ext>
            </a:extLst>
          </p:cNvPr>
          <p:cNvSpPr txBox="1"/>
          <p:nvPr/>
        </p:nvSpPr>
        <p:spPr>
          <a:xfrm>
            <a:off x="405143" y="387850"/>
            <a:ext cx="3523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</a:t>
            </a:r>
          </a:p>
          <a:p>
            <a:endParaRPr lang="en-US" b="1" dirty="0"/>
          </a:p>
        </p:txBody>
      </p:sp>
      <p:pic>
        <p:nvPicPr>
          <p:cNvPr id="5" name="Picture 2" descr="PINOT &#10;12.2% (116) &#10;0.0% &#10;9.0% &#10;(85) &#10;63.0% &#10;(597) &#10;6.0% &#10;(57) &#10;7.7% (73) &#10;MIST &#10;2.1% (20) &#10;HIPPIE ">
            <a:extLst>
              <a:ext uri="{FF2B5EF4-FFF2-40B4-BE49-F238E27FC236}">
                <a16:creationId xmlns:a16="http://schemas.microsoft.com/office/drawing/2014/main" id="{D5D7D671-0011-9D64-BBC0-08C89E5437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9037" y="1362710"/>
            <a:ext cx="5181600" cy="4610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A5E02BF-2664-F223-248E-968F2DA6DE4F}"/>
              </a:ext>
            </a:extLst>
          </p:cNvPr>
          <p:cNvSpPr/>
          <p:nvPr/>
        </p:nvSpPr>
        <p:spPr>
          <a:xfrm>
            <a:off x="307875" y="7433094"/>
            <a:ext cx="694392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Proportion of interactions, meeting QC requirements 1 &amp; 2, captured by the PINOT, HIPPIE and MIST databases.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re is significant overlap between the database searches, 63% of total interactions across the interactomes are captured by all 3. Of the 948 unique interactions; 84.2% are captured by PINOT, 71.1% by HIPPIE, with the highest proportion ,85.7%, captured by MIST.</a:t>
            </a:r>
          </a:p>
        </p:txBody>
      </p:sp>
    </p:spTree>
    <p:extLst>
      <p:ext uri="{BB962C8B-B14F-4D97-AF65-F5344CB8AC3E}">
        <p14:creationId xmlns:p14="http://schemas.microsoft.com/office/powerpoint/2010/main" val="3867506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E69910A0-0230-4C3D-76B6-6C1C9F3799FC}"/>
              </a:ext>
            </a:extLst>
          </p:cNvPr>
          <p:cNvSpPr/>
          <p:nvPr/>
        </p:nvSpPr>
        <p:spPr>
          <a:xfrm>
            <a:off x="130703" y="7273133"/>
            <a:ext cx="729826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3: 74% of interactions were retained, post- </a:t>
            </a:r>
            <a:r>
              <a:rPr lang="en-US" altLang="en-US" sz="1200" b="1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resholding. </a:t>
            </a:r>
            <a:r>
              <a:rPr lang="en-US" altLang="en-US" sz="1200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rt displays the percentage retention, 'post-threshold', compared with the pre-threshold interaction count ('Interactions') across the 9 interactomes. 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E8A7295-DC49-1FE8-BEBB-E7BD359AAD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635451"/>
            <a:ext cx="7559675" cy="437104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8B5F23F-8CF7-4613-9D2D-867AE25187AF}"/>
              </a:ext>
            </a:extLst>
          </p:cNvPr>
          <p:cNvSpPr txBox="1"/>
          <p:nvPr/>
        </p:nvSpPr>
        <p:spPr>
          <a:xfrm>
            <a:off x="405143" y="387850"/>
            <a:ext cx="3523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</a:t>
            </a:r>
          </a:p>
          <a:p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996306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4BC76EE-BB53-8B4E-A3DC-EE5D66150E9F}"/>
              </a:ext>
            </a:extLst>
          </p:cNvPr>
          <p:cNvSpPr txBox="1"/>
          <p:nvPr/>
        </p:nvSpPr>
        <p:spPr>
          <a:xfrm>
            <a:off x="196971" y="6918566"/>
            <a:ext cx="716573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4: Enrichment of PD associated genes in complete </a:t>
            </a:r>
            <a:r>
              <a:rPr lang="en-US" altLang="en-US" sz="1200" b="1" i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-CORE network </a:t>
            </a: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ets statistical significance. </a:t>
            </a:r>
            <a:r>
              <a:rPr lang="en-US" altLang="en-US" sz="1200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normal distribution, generated by the</a:t>
            </a: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,000 Random Simulations test for significance </a:t>
            </a:r>
            <a:r>
              <a:rPr lang="en-US" altLang="en-US" sz="1200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als a mean of ~25 overlaps with 2832 random genes. The true number of overlaps (45) is illustrated by a yellow star and arrow. The generated </a:t>
            </a:r>
            <a:r>
              <a:rPr lang="en-US" altLang="en-US" sz="1200" i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en-US" sz="1200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 for this significance =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.48 x 10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5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E4D9F4-513F-5B87-5CA3-EBB057744DB8}"/>
              </a:ext>
            </a:extLst>
          </p:cNvPr>
          <p:cNvSpPr txBox="1"/>
          <p:nvPr/>
        </p:nvSpPr>
        <p:spPr>
          <a:xfrm>
            <a:off x="405143" y="387850"/>
            <a:ext cx="3523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</a:t>
            </a:r>
          </a:p>
          <a:p>
            <a:endParaRPr lang="en-US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B6240D1-0D19-9646-D5BD-EAB51B84AE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12240"/>
            <a:ext cx="7559675" cy="53220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18867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7267B58-9A7F-DE6A-D095-5544406B7B58}"/>
              </a:ext>
            </a:extLst>
          </p:cNvPr>
          <p:cNvSpPr txBox="1"/>
          <p:nvPr/>
        </p:nvSpPr>
        <p:spPr>
          <a:xfrm>
            <a:off x="196971" y="7323012"/>
            <a:ext cx="716573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5: Enrichment of Mendelian PD genes in complete </a:t>
            </a:r>
            <a:r>
              <a:rPr lang="en-US" altLang="en-US" sz="1200" b="1" i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-CORE network </a:t>
            </a: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ets statistical significance. </a:t>
            </a:r>
            <a:r>
              <a:rPr lang="en-US" altLang="en-US" sz="1200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normal distribution, generated by the</a:t>
            </a:r>
            <a:r>
              <a:rPr lang="en-US" altLang="en-US" sz="1200" b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00,000 Random Simulations test for significance </a:t>
            </a:r>
            <a:r>
              <a:rPr lang="en-US" altLang="en-US" sz="1200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als a mean of ~2  overlaps with 2832 random genes. The true number of overlaps (8) is illustrated by a yellow star and arrow. The generated </a:t>
            </a:r>
            <a:r>
              <a:rPr lang="en-US" altLang="en-US" sz="1200" i="1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en-US" sz="1200" dirty="0">
                <a:solidFill>
                  <a:srgbClr val="2F2F2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 for this significance =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.81  x 10</a:t>
            </a:r>
            <a:r>
              <a:rPr lang="en-GB" sz="12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6</a:t>
            </a:r>
            <a:r>
              <a:rPr lang="en-GB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.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8B2568D-64CA-3FC0-8A16-879DA1ACEE76}"/>
              </a:ext>
            </a:extLst>
          </p:cNvPr>
          <p:cNvSpPr txBox="1"/>
          <p:nvPr/>
        </p:nvSpPr>
        <p:spPr>
          <a:xfrm>
            <a:off x="405143" y="387850"/>
            <a:ext cx="3523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5</a:t>
            </a:r>
          </a:p>
          <a:p>
            <a:endParaRPr lang="en-US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A6723C4-D436-9E31-0EDB-63D59A4F99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2190" y="2353138"/>
            <a:ext cx="6295292" cy="45432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0257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8</TotalTime>
  <Words>298</Words>
  <Application>Microsoft Macintosh PowerPoint</Application>
  <PresentationFormat>Custom</PresentationFormat>
  <Paragraphs>1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y, Katie</dc:creator>
  <cp:lastModifiedBy>Kelly, Katie</cp:lastModifiedBy>
  <cp:revision>40</cp:revision>
  <dcterms:created xsi:type="dcterms:W3CDTF">2022-07-29T12:16:40Z</dcterms:created>
  <dcterms:modified xsi:type="dcterms:W3CDTF">2022-11-21T17:28:20Z</dcterms:modified>
</cp:coreProperties>
</file>